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fntdata" ContentType="application/x-fontdata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embedTrueTypeFonts="1">
  <p:sldMasterIdLst>
    <p:sldMasterId id="2147483648" r:id="rId1"/>
  </p:sldMasterIdLst>
  <p:sldIdLst>
    <p:sldId id="261" r:id="rId2"/>
  </p:sldIdLst>
  <p:sldSz cx="12192000" cy="6858000"/>
  <p:notesSz cx="6858000" cy="9144000"/>
  <p:embeddedFontLst>
    <p:embeddedFont>
      <p:font typeface="Calibri" panose="020F0502020204030204" pitchFamily="34" charset="0"/>
      <p:regular r:id="rId3"/>
      <p:bold r:id="rId4"/>
      <p:italic r:id="rId5"/>
      <p:boldItalic r:id="rId6"/>
    </p:embeddedFont>
    <p:embeddedFont>
      <p:font typeface="Calibri Light" panose="020F0302020204030204" pitchFamily="34" charset="0"/>
      <p:regular r:id="rId7"/>
      <p:italic r:id="rId8"/>
    </p:embeddedFont>
  </p:embeddedFontLst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5" autoAdjust="0"/>
    <p:restoredTop sz="94660"/>
  </p:normalViewPr>
  <p:slideViewPr>
    <p:cSldViewPr snapToGrid="0" showGuides="1">
      <p:cViewPr varScale="1">
        <p:scale>
          <a:sx n="116" d="100"/>
          <a:sy n="116" d="100"/>
        </p:scale>
        <p:origin x="138" y="37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font" Target="fonts/font6.fntdata"/><Relationship Id="rId3" Type="http://schemas.openxmlformats.org/officeDocument/2006/relationships/font" Target="fonts/font1.fntdata"/><Relationship Id="rId7" Type="http://schemas.openxmlformats.org/officeDocument/2006/relationships/font" Target="fonts/font5.fntdata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font" Target="fonts/font4.fntdata"/><Relationship Id="rId11" Type="http://schemas.openxmlformats.org/officeDocument/2006/relationships/theme" Target="theme/theme1.xml"/><Relationship Id="rId5" Type="http://schemas.openxmlformats.org/officeDocument/2006/relationships/font" Target="fonts/font3.fntdata"/><Relationship Id="rId10" Type="http://schemas.openxmlformats.org/officeDocument/2006/relationships/viewProps" Target="viewProps.xml"/><Relationship Id="rId4" Type="http://schemas.openxmlformats.org/officeDocument/2006/relationships/font" Target="fonts/font2.fntdata"/><Relationship Id="rId9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-Arbeitsblat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-Arbeitsblat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-Arbeitsblatt2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-Arbeitsblatt3.xlsx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de-AT"/>
              <a:t>negative control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title>
    <c:autoTitleDeleted val="0"/>
    <c:plotArea>
      <c:layout/>
      <c:lineChart>
        <c:grouping val="standard"/>
        <c:varyColors val="0"/>
        <c:ser>
          <c:idx val="5"/>
          <c:order val="5"/>
          <c:tx>
            <c:strRef>
              <c:f>'CD8 graphs'!$B$7</c:f>
              <c:strCache>
                <c:ptCount val="1"/>
                <c:pt idx="0">
                  <c:v>mean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strRef>
              <c:f>'CD8 graphs'!$C$1:$H$1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cat>
          <c:val>
            <c:numRef>
              <c:f>'CD8 graphs'!$C$7:$H$7</c:f>
              <c:numCache>
                <c:formatCode>General</c:formatCode>
                <c:ptCount val="6"/>
                <c:pt idx="0">
                  <c:v>173898.818</c:v>
                </c:pt>
                <c:pt idx="1">
                  <c:v>207191.72839999999</c:v>
                </c:pt>
                <c:pt idx="2">
                  <c:v>430934.27999999997</c:v>
                </c:pt>
                <c:pt idx="3">
                  <c:v>288716.52100000001</c:v>
                </c:pt>
                <c:pt idx="4">
                  <c:v>137963.60270909089</c:v>
                </c:pt>
                <c:pt idx="5">
                  <c:v>301585.1550000000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A382-4D71-8BDF-7D95F4BFACE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28928088"/>
        <c:axId val="513748280"/>
      </c:lineChart>
      <c:scatterChart>
        <c:scatterStyle val="lineMarker"/>
        <c:varyColors val="0"/>
        <c:ser>
          <c:idx val="0"/>
          <c:order val="0"/>
          <c:tx>
            <c:strRef>
              <c:f>'CD8 graphs'!$B$2</c:f>
              <c:strCache>
                <c:ptCount val="1"/>
                <c:pt idx="0">
                  <c:v>1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strRef>
              <c:f>'CD8 graphs'!$C$1:$H$1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xVal>
          <c:yVal>
            <c:numRef>
              <c:f>'CD8 graphs'!$C$2:$H$2</c:f>
              <c:numCache>
                <c:formatCode>General</c:formatCode>
                <c:ptCount val="6"/>
                <c:pt idx="0">
                  <c:v>279382.95</c:v>
                </c:pt>
                <c:pt idx="1">
                  <c:v>147346.65</c:v>
                </c:pt>
                <c:pt idx="2">
                  <c:v>543876</c:v>
                </c:pt>
                <c:pt idx="3">
                  <c:v>192139.78</c:v>
                </c:pt>
                <c:pt idx="4">
                  <c:v>160760.58000000005</c:v>
                </c:pt>
                <c:pt idx="5">
                  <c:v>502607.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A382-4D71-8BDF-7D95F4BFACEA}"/>
            </c:ext>
          </c:extLst>
        </c:ser>
        <c:ser>
          <c:idx val="1"/>
          <c:order val="1"/>
          <c:tx>
            <c:strRef>
              <c:f>'CD8 graphs'!$B$3</c:f>
              <c:strCache>
                <c:ptCount val="1"/>
                <c:pt idx="0">
                  <c:v>2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strRef>
              <c:f>'CD8 graphs'!$C$1:$H$1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xVal>
          <c:yVal>
            <c:numRef>
              <c:f>'CD8 graphs'!$C$3:$H$3</c:f>
              <c:numCache>
                <c:formatCode>General</c:formatCode>
                <c:ptCount val="6"/>
                <c:pt idx="0">
                  <c:v>157013.94399999999</c:v>
                </c:pt>
                <c:pt idx="1">
                  <c:v>338380.41600000003</c:v>
                </c:pt>
                <c:pt idx="2">
                  <c:v>303875</c:v>
                </c:pt>
                <c:pt idx="3">
                  <c:v>230766.48000000004</c:v>
                </c:pt>
                <c:pt idx="4">
                  <c:v>128733.125</c:v>
                </c:pt>
                <c:pt idx="5">
                  <c:v>222032.3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A382-4D71-8BDF-7D95F4BFACEA}"/>
            </c:ext>
          </c:extLst>
        </c:ser>
        <c:ser>
          <c:idx val="2"/>
          <c:order val="2"/>
          <c:tx>
            <c:strRef>
              <c:f>'CD8 graphs'!$B$4</c:f>
              <c:strCache>
                <c:ptCount val="1"/>
                <c:pt idx="0">
                  <c:v>3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strRef>
              <c:f>'CD8 graphs'!$C$1:$H$1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xVal>
          <c:yVal>
            <c:numRef>
              <c:f>'CD8 graphs'!$C$4:$H$4</c:f>
              <c:numCache>
                <c:formatCode>General</c:formatCode>
                <c:ptCount val="6"/>
                <c:pt idx="0">
                  <c:v>95785.535999999993</c:v>
                </c:pt>
                <c:pt idx="1">
                  <c:v>162042.29100000003</c:v>
                </c:pt>
                <c:pt idx="2">
                  <c:v>280574.8</c:v>
                </c:pt>
                <c:pt idx="3">
                  <c:v>677263.3</c:v>
                </c:pt>
                <c:pt idx="4">
                  <c:v>80837.754000000001</c:v>
                </c:pt>
                <c:pt idx="5">
                  <c:v>180115.424999999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A382-4D71-8BDF-7D95F4BFACEA}"/>
            </c:ext>
          </c:extLst>
        </c:ser>
        <c:ser>
          <c:idx val="3"/>
          <c:order val="3"/>
          <c:tx>
            <c:strRef>
              <c:f>'CD8 graphs'!$B$5</c:f>
              <c:strCache>
                <c:ptCount val="1"/>
                <c:pt idx="0">
                  <c:v>4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strRef>
              <c:f>'CD8 graphs'!$C$1:$H$1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xVal>
          <c:yVal>
            <c:numRef>
              <c:f>'CD8 graphs'!$C$5:$H$5</c:f>
              <c:numCache>
                <c:formatCode>General</c:formatCode>
                <c:ptCount val="6"/>
                <c:pt idx="0">
                  <c:v>33750.780000000006</c:v>
                </c:pt>
                <c:pt idx="1">
                  <c:v>152330.72500000001</c:v>
                </c:pt>
                <c:pt idx="2">
                  <c:v>256267.19999999995</c:v>
                </c:pt>
                <c:pt idx="3">
                  <c:v>154433.52000000002</c:v>
                </c:pt>
                <c:pt idx="4">
                  <c:v>233040.7363636363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A382-4D71-8BDF-7D95F4BFACEA}"/>
            </c:ext>
          </c:extLst>
        </c:ser>
        <c:ser>
          <c:idx val="4"/>
          <c:order val="4"/>
          <c:tx>
            <c:strRef>
              <c:f>'CD8 graphs'!$B$6</c:f>
              <c:strCache>
                <c:ptCount val="1"/>
                <c:pt idx="0">
                  <c:v>5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strRef>
              <c:f>'CD8 graphs'!$C$1:$H$1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xVal>
          <c:yVal>
            <c:numRef>
              <c:f>'CD8 graphs'!$C$6:$H$6</c:f>
              <c:numCache>
                <c:formatCode>General</c:formatCode>
                <c:ptCount val="6"/>
                <c:pt idx="0">
                  <c:v>303560.88</c:v>
                </c:pt>
                <c:pt idx="1">
                  <c:v>235858.56</c:v>
                </c:pt>
                <c:pt idx="2">
                  <c:v>770078.39999999991</c:v>
                </c:pt>
                <c:pt idx="3">
                  <c:v>188979.52499999999</c:v>
                </c:pt>
                <c:pt idx="4">
                  <c:v>86445.81818181817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A382-4D71-8BDF-7D95F4BFACE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49715392"/>
        <c:axId val="549715720"/>
      </c:scatterChart>
      <c:catAx>
        <c:axId val="52892808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513748280"/>
        <c:crosses val="autoZero"/>
        <c:auto val="1"/>
        <c:lblAlgn val="ctr"/>
        <c:lblOffset val="100"/>
        <c:noMultiLvlLbl val="0"/>
      </c:catAx>
      <c:valAx>
        <c:axId val="513748280"/>
        <c:scaling>
          <c:orientation val="minMax"/>
          <c:max val="2500000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528928088"/>
        <c:crosses val="autoZero"/>
        <c:crossBetween val="between"/>
        <c:majorUnit val="500000"/>
        <c:dispUnits>
          <c:builtInUnit val="hundredThousands"/>
          <c:dispUnitsLbl>
            <c:layout>
              <c:manualLayout>
                <c:xMode val="edge"/>
                <c:yMode val="edge"/>
                <c:x val="2.6780921708457941E-2"/>
                <c:y val="0.35100306748466259"/>
              </c:manualLayout>
            </c:layout>
            <c:tx>
              <c:rich>
                <a:bodyPr rot="-5400000" spcFirstLastPara="1" vertOverflow="ellipsis" vert="horz" wrap="square" anchor="ctr" anchorCtr="1"/>
                <a:lstStyle/>
                <a:p>
                  <a:pPr>
                    <a:defRPr sz="10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r>
                    <a:rPr lang="de-AT" sz="1000" b="0" i="0" baseline="0">
                      <a:effectLst/>
                    </a:rPr>
                    <a:t>10</a:t>
                  </a:r>
                  <a:r>
                    <a:rPr lang="de-AT" sz="1000" b="0" i="0" baseline="30000">
                      <a:effectLst/>
                    </a:rPr>
                    <a:t>5 </a:t>
                  </a:r>
                  <a:r>
                    <a:rPr lang="de-AT" sz="1000" b="0" i="0" baseline="0">
                      <a:effectLst/>
                    </a:rPr>
                    <a:t>cells/ml</a:t>
                  </a:r>
                  <a:endParaRPr lang="de-AT" sz="1000">
                    <a:effectLst/>
                  </a:endParaRPr>
                </a:p>
              </c:rich>
            </c:tx>
            <c:spPr>
              <a:noFill/>
              <a:ln>
                <a:noFill/>
              </a:ln>
              <a:effectLst/>
            </c:spPr>
            <c:txPr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de-DE"/>
              </a:p>
            </c:txPr>
          </c:dispUnitsLbl>
        </c:dispUnits>
      </c:valAx>
      <c:valAx>
        <c:axId val="549715720"/>
        <c:scaling>
          <c:orientation val="minMax"/>
          <c:max val="2500000"/>
        </c:scaling>
        <c:delete val="1"/>
        <c:axPos val="r"/>
        <c:numFmt formatCode="General" sourceLinked="1"/>
        <c:majorTickMark val="out"/>
        <c:minorTickMark val="none"/>
        <c:tickLblPos val="nextTo"/>
        <c:crossAx val="549715392"/>
        <c:crosses val="max"/>
        <c:crossBetween val="midCat"/>
      </c:valAx>
      <c:valAx>
        <c:axId val="549715392"/>
        <c:scaling>
          <c:orientation val="minMax"/>
        </c:scaling>
        <c:delete val="1"/>
        <c:axPos val="t"/>
        <c:majorTickMark val="out"/>
        <c:minorTickMark val="none"/>
        <c:tickLblPos val="nextTo"/>
        <c:crossAx val="549715720"/>
        <c:crosses val="max"/>
        <c:crossBetween val="midCat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de-AT"/>
              <a:t>vaccination-only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title>
    <c:autoTitleDeleted val="0"/>
    <c:plotArea>
      <c:layout/>
      <c:lineChart>
        <c:grouping val="standard"/>
        <c:varyColors val="0"/>
        <c:ser>
          <c:idx val="5"/>
          <c:order val="5"/>
          <c:tx>
            <c:strRef>
              <c:f>'CD8 graphs'!$B$16</c:f>
              <c:strCache>
                <c:ptCount val="1"/>
                <c:pt idx="0">
                  <c:v>mean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strRef>
              <c:f>'CD8 graphs'!$C$10:$H$10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cat>
          <c:val>
            <c:numRef>
              <c:f>'CD8 graphs'!$C$16:$H$16</c:f>
              <c:numCache>
                <c:formatCode>General</c:formatCode>
                <c:ptCount val="6"/>
                <c:pt idx="0">
                  <c:v>289655.20600000001</c:v>
                </c:pt>
                <c:pt idx="1">
                  <c:v>435924.62399999995</c:v>
                </c:pt>
                <c:pt idx="2">
                  <c:v>773871.39899999998</c:v>
                </c:pt>
                <c:pt idx="3">
                  <c:v>345813.81599999993</c:v>
                </c:pt>
                <c:pt idx="4">
                  <c:v>240884.17080000002</c:v>
                </c:pt>
                <c:pt idx="5">
                  <c:v>432513.2863333332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0D5D-4738-9F9A-1CB9A23A4DA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26275128"/>
        <c:axId val="526271192"/>
      </c:lineChart>
      <c:scatterChart>
        <c:scatterStyle val="lineMarker"/>
        <c:varyColors val="0"/>
        <c:ser>
          <c:idx val="0"/>
          <c:order val="0"/>
          <c:tx>
            <c:strRef>
              <c:f>'CD8 graphs'!$B$11</c:f>
              <c:strCache>
                <c:ptCount val="1"/>
                <c:pt idx="0">
                  <c:v>6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strRef>
              <c:f>'CD8 graphs'!$C$10:$H$10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xVal>
          <c:yVal>
            <c:numRef>
              <c:f>'CD8 graphs'!$C$11:$H$11</c:f>
              <c:numCache>
                <c:formatCode>General</c:formatCode>
                <c:ptCount val="6"/>
                <c:pt idx="0">
                  <c:v>487523.04999999993</c:v>
                </c:pt>
                <c:pt idx="1">
                  <c:v>838240.2</c:v>
                </c:pt>
                <c:pt idx="2">
                  <c:v>1183936.5</c:v>
                </c:pt>
                <c:pt idx="3">
                  <c:v>432998.99999999994</c:v>
                </c:pt>
                <c:pt idx="4">
                  <c:v>441076.03200000001</c:v>
                </c:pt>
                <c:pt idx="5">
                  <c:v>801511.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0D5D-4738-9F9A-1CB9A23A4DA2}"/>
            </c:ext>
          </c:extLst>
        </c:ser>
        <c:ser>
          <c:idx val="1"/>
          <c:order val="1"/>
          <c:tx>
            <c:strRef>
              <c:f>'CD8 graphs'!$B$12</c:f>
              <c:strCache>
                <c:ptCount val="1"/>
                <c:pt idx="0">
                  <c:v>7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strRef>
              <c:f>'CD8 graphs'!$C$10:$H$10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xVal>
          <c:yVal>
            <c:numRef>
              <c:f>'CD8 graphs'!$C$12:$H$12</c:f>
              <c:numCache>
                <c:formatCode>General</c:formatCode>
                <c:ptCount val="6"/>
                <c:pt idx="0">
                  <c:v>469537.64</c:v>
                </c:pt>
                <c:pt idx="1">
                  <c:v>426495.22499999998</c:v>
                </c:pt>
                <c:pt idx="2">
                  <c:v>729911.25</c:v>
                </c:pt>
                <c:pt idx="3">
                  <c:v>273543.59999999998</c:v>
                </c:pt>
                <c:pt idx="4">
                  <c:v>451093.65</c:v>
                </c:pt>
                <c:pt idx="5">
                  <c:v>190426.1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0D5D-4738-9F9A-1CB9A23A4DA2}"/>
            </c:ext>
          </c:extLst>
        </c:ser>
        <c:ser>
          <c:idx val="2"/>
          <c:order val="2"/>
          <c:tx>
            <c:strRef>
              <c:f>'CD8 graphs'!$B$13</c:f>
              <c:strCache>
                <c:ptCount val="1"/>
                <c:pt idx="0">
                  <c:v>8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strRef>
              <c:f>'CD8 graphs'!$C$10:$H$10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xVal>
          <c:yVal>
            <c:numRef>
              <c:f>'CD8 graphs'!$C$13:$H$13</c:f>
              <c:numCache>
                <c:formatCode>General</c:formatCode>
                <c:ptCount val="6"/>
                <c:pt idx="0">
                  <c:v>245435.3</c:v>
                </c:pt>
                <c:pt idx="1">
                  <c:v>445950.85499999998</c:v>
                </c:pt>
                <c:pt idx="2">
                  <c:v>732564</c:v>
                </c:pt>
                <c:pt idx="3">
                  <c:v>499680.00000000006</c:v>
                </c:pt>
                <c:pt idx="4">
                  <c:v>36791.612000000001</c:v>
                </c:pt>
                <c:pt idx="5">
                  <c:v>305602.478999999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0D5D-4738-9F9A-1CB9A23A4DA2}"/>
            </c:ext>
          </c:extLst>
        </c:ser>
        <c:ser>
          <c:idx val="3"/>
          <c:order val="3"/>
          <c:tx>
            <c:strRef>
              <c:f>'CD8 graphs'!$B$14</c:f>
              <c:strCache>
                <c:ptCount val="1"/>
                <c:pt idx="0">
                  <c:v>9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strRef>
              <c:f>'CD8 graphs'!$C$10:$H$10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xVal>
          <c:yVal>
            <c:numRef>
              <c:f>'CD8 graphs'!$C$14:$H$14</c:f>
              <c:numCache>
                <c:formatCode>General</c:formatCode>
                <c:ptCount val="6"/>
                <c:pt idx="0">
                  <c:v>182572.59</c:v>
                </c:pt>
                <c:pt idx="1">
                  <c:v>97318.2</c:v>
                </c:pt>
                <c:pt idx="2">
                  <c:v>442748.44500000001</c:v>
                </c:pt>
                <c:pt idx="3">
                  <c:v>127699.95000000001</c:v>
                </c:pt>
                <c:pt idx="4">
                  <c:v>64143.84799999999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0D5D-4738-9F9A-1CB9A23A4DA2}"/>
            </c:ext>
          </c:extLst>
        </c:ser>
        <c:ser>
          <c:idx val="4"/>
          <c:order val="4"/>
          <c:tx>
            <c:strRef>
              <c:f>'CD8 graphs'!$B$15</c:f>
              <c:strCache>
                <c:ptCount val="1"/>
                <c:pt idx="0">
                  <c:v>10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strRef>
              <c:f>'CD8 graphs'!$C$10:$H$10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xVal>
          <c:yVal>
            <c:numRef>
              <c:f>'CD8 graphs'!$C$15:$H$15</c:f>
              <c:numCache>
                <c:formatCode>General</c:formatCode>
                <c:ptCount val="6"/>
                <c:pt idx="0">
                  <c:v>63207.45</c:v>
                </c:pt>
                <c:pt idx="1">
                  <c:v>371618.64</c:v>
                </c:pt>
                <c:pt idx="2">
                  <c:v>780196.8</c:v>
                </c:pt>
                <c:pt idx="3">
                  <c:v>395146.52999999991</c:v>
                </c:pt>
                <c:pt idx="4">
                  <c:v>211315.71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0D5D-4738-9F9A-1CB9A23A4DA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17694704"/>
        <c:axId val="517691096"/>
      </c:scatterChart>
      <c:catAx>
        <c:axId val="52627512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526271192"/>
        <c:crosses val="autoZero"/>
        <c:auto val="1"/>
        <c:lblAlgn val="ctr"/>
        <c:lblOffset val="100"/>
        <c:noMultiLvlLbl val="0"/>
      </c:catAx>
      <c:valAx>
        <c:axId val="526271192"/>
        <c:scaling>
          <c:orientation val="minMax"/>
          <c:max val="25000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526275128"/>
        <c:crosses val="autoZero"/>
        <c:crossBetween val="between"/>
        <c:majorUnit val="500000"/>
        <c:dispUnits>
          <c:builtInUnit val="hundredThousands"/>
          <c:dispUnitsLbl>
            <c:layout>
              <c:manualLayout>
                <c:xMode val="edge"/>
                <c:yMode val="edge"/>
                <c:x val="2.1911663216011044E-2"/>
                <c:y val="0.35100306748466259"/>
              </c:manualLayout>
            </c:layout>
            <c:tx>
              <c:rich>
                <a:bodyPr rot="-5400000" spcFirstLastPara="1" vertOverflow="ellipsis" vert="horz" wrap="square" anchor="ctr" anchorCtr="1"/>
                <a:lstStyle/>
                <a:p>
                  <a:pPr>
                    <a:defRPr sz="10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r>
                    <a:rPr lang="de-AT" sz="1000" b="0" i="0" baseline="0">
                      <a:effectLst/>
                    </a:rPr>
                    <a:t>10</a:t>
                  </a:r>
                  <a:r>
                    <a:rPr lang="de-AT" sz="1000" b="0" i="0" baseline="30000">
                      <a:effectLst/>
                    </a:rPr>
                    <a:t>5 </a:t>
                  </a:r>
                  <a:r>
                    <a:rPr lang="de-AT" sz="1000" b="0" i="0" baseline="0">
                      <a:effectLst/>
                    </a:rPr>
                    <a:t>cells/ml</a:t>
                  </a:r>
                  <a:endParaRPr lang="de-AT" sz="1000">
                    <a:effectLst/>
                  </a:endParaRPr>
                </a:p>
              </c:rich>
            </c:tx>
            <c:spPr>
              <a:noFill/>
              <a:ln>
                <a:noFill/>
              </a:ln>
              <a:effectLst/>
            </c:spPr>
            <c:txPr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de-DE"/>
              </a:p>
            </c:txPr>
          </c:dispUnitsLbl>
        </c:dispUnits>
      </c:valAx>
      <c:valAx>
        <c:axId val="517691096"/>
        <c:scaling>
          <c:orientation val="minMax"/>
          <c:max val="2500000"/>
        </c:scaling>
        <c:delete val="1"/>
        <c:axPos val="r"/>
        <c:numFmt formatCode="General" sourceLinked="1"/>
        <c:majorTickMark val="out"/>
        <c:minorTickMark val="none"/>
        <c:tickLblPos val="nextTo"/>
        <c:crossAx val="517694704"/>
        <c:crosses val="max"/>
        <c:crossBetween val="midCat"/>
      </c:valAx>
      <c:valAx>
        <c:axId val="517694704"/>
        <c:scaling>
          <c:orientation val="minMax"/>
        </c:scaling>
        <c:delete val="1"/>
        <c:axPos val="t"/>
        <c:majorTickMark val="out"/>
        <c:minorTickMark val="none"/>
        <c:tickLblPos val="nextTo"/>
        <c:crossAx val="517691096"/>
        <c:crosses val="max"/>
        <c:crossBetween val="midCat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de-AT"/>
              <a:t>challenge control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title>
    <c:autoTitleDeleted val="0"/>
    <c:plotArea>
      <c:layout/>
      <c:lineChart>
        <c:grouping val="standard"/>
        <c:varyColors val="0"/>
        <c:ser>
          <c:idx val="5"/>
          <c:order val="5"/>
          <c:tx>
            <c:strRef>
              <c:f>'CD8 graphs'!$B$25</c:f>
              <c:strCache>
                <c:ptCount val="1"/>
                <c:pt idx="0">
                  <c:v>mean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strRef>
              <c:f>'CD8 graphs'!$C$19:$H$19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cat>
          <c:val>
            <c:numRef>
              <c:f>'CD8 graphs'!$C$25:$H$25</c:f>
              <c:numCache>
                <c:formatCode>General</c:formatCode>
                <c:ptCount val="6"/>
                <c:pt idx="0">
                  <c:v>255910.36299999998</c:v>
                </c:pt>
                <c:pt idx="1">
                  <c:v>307048.65899999999</c:v>
                </c:pt>
                <c:pt idx="2">
                  <c:v>1348146.5179999999</c:v>
                </c:pt>
                <c:pt idx="3">
                  <c:v>2378567.2489999998</c:v>
                </c:pt>
                <c:pt idx="4">
                  <c:v>492570.12499999988</c:v>
                </c:pt>
                <c:pt idx="5">
                  <c:v>1138174.913333333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EB12-4131-821C-68A8BE0FD9A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28911688"/>
        <c:axId val="528910704"/>
      </c:lineChart>
      <c:scatterChart>
        <c:scatterStyle val="lineMarker"/>
        <c:varyColors val="0"/>
        <c:ser>
          <c:idx val="0"/>
          <c:order val="0"/>
          <c:tx>
            <c:strRef>
              <c:f>'CD8 graphs'!$B$20</c:f>
              <c:strCache>
                <c:ptCount val="1"/>
                <c:pt idx="0">
                  <c:v>11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strRef>
              <c:f>'CD8 graphs'!$C$19:$H$19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xVal>
          <c:yVal>
            <c:numRef>
              <c:f>'CD8 graphs'!$C$20:$H$20</c:f>
              <c:numCache>
                <c:formatCode>General</c:formatCode>
                <c:ptCount val="6"/>
                <c:pt idx="0">
                  <c:v>451476.47999999998</c:v>
                </c:pt>
                <c:pt idx="1">
                  <c:v>463296.07500000001</c:v>
                </c:pt>
                <c:pt idx="2">
                  <c:v>1854618.1499999994</c:v>
                </c:pt>
                <c:pt idx="3">
                  <c:v>2473603.92</c:v>
                </c:pt>
                <c:pt idx="4">
                  <c:v>554864.18000000005</c:v>
                </c:pt>
                <c:pt idx="5">
                  <c:v>210108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EB12-4131-821C-68A8BE0FD9A0}"/>
            </c:ext>
          </c:extLst>
        </c:ser>
        <c:ser>
          <c:idx val="1"/>
          <c:order val="1"/>
          <c:tx>
            <c:strRef>
              <c:f>'CD8 graphs'!$B$21</c:f>
              <c:strCache>
                <c:ptCount val="1"/>
                <c:pt idx="0">
                  <c:v>12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strRef>
              <c:f>'CD8 graphs'!$C$19:$H$19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xVal>
          <c:yVal>
            <c:numRef>
              <c:f>'CD8 graphs'!$C$21:$H$21</c:f>
              <c:numCache>
                <c:formatCode>General</c:formatCode>
                <c:ptCount val="6"/>
                <c:pt idx="0">
                  <c:v>173855.88</c:v>
                </c:pt>
                <c:pt idx="1">
                  <c:v>308736</c:v>
                </c:pt>
                <c:pt idx="2">
                  <c:v>3108533.68</c:v>
                </c:pt>
                <c:pt idx="3">
                  <c:v>2821337.6</c:v>
                </c:pt>
                <c:pt idx="4">
                  <c:v>784262.32499999995</c:v>
                </c:pt>
                <c:pt idx="5">
                  <c:v>227263.1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EB12-4131-821C-68A8BE0FD9A0}"/>
            </c:ext>
          </c:extLst>
        </c:ser>
        <c:ser>
          <c:idx val="2"/>
          <c:order val="2"/>
          <c:tx>
            <c:strRef>
              <c:f>'CD8 graphs'!$B$22</c:f>
              <c:strCache>
                <c:ptCount val="1"/>
                <c:pt idx="0">
                  <c:v>13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strRef>
              <c:f>'CD8 graphs'!$C$19:$H$19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xVal>
          <c:yVal>
            <c:numRef>
              <c:f>'CD8 graphs'!$C$22:$H$22</c:f>
              <c:numCache>
                <c:formatCode>General</c:formatCode>
                <c:ptCount val="6"/>
                <c:pt idx="0">
                  <c:v>246183.728</c:v>
                </c:pt>
                <c:pt idx="1">
                  <c:v>376057.5</c:v>
                </c:pt>
                <c:pt idx="2">
                  <c:v>710421.4</c:v>
                </c:pt>
                <c:pt idx="3">
                  <c:v>2915721.0000000005</c:v>
                </c:pt>
                <c:pt idx="4">
                  <c:v>644476.31999999995</c:v>
                </c:pt>
                <c:pt idx="5">
                  <c:v>1086177.6000000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EB12-4131-821C-68A8BE0FD9A0}"/>
            </c:ext>
          </c:extLst>
        </c:ser>
        <c:ser>
          <c:idx val="3"/>
          <c:order val="3"/>
          <c:tx>
            <c:strRef>
              <c:f>'CD8 graphs'!$B$23</c:f>
              <c:strCache>
                <c:ptCount val="1"/>
                <c:pt idx="0">
                  <c:v>14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strRef>
              <c:f>'CD8 graphs'!$C$19:$H$19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xVal>
          <c:yVal>
            <c:numRef>
              <c:f>'CD8 graphs'!$C$23:$H$23</c:f>
              <c:numCache>
                <c:formatCode>General</c:formatCode>
                <c:ptCount val="6"/>
                <c:pt idx="0">
                  <c:v>305878.815</c:v>
                </c:pt>
                <c:pt idx="1">
                  <c:v>174049.47</c:v>
                </c:pt>
                <c:pt idx="2">
                  <c:v>582414.05000000005</c:v>
                </c:pt>
                <c:pt idx="3">
                  <c:v>2541231.125</c:v>
                </c:pt>
                <c:pt idx="4">
                  <c:v>17066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EB12-4131-821C-68A8BE0FD9A0}"/>
            </c:ext>
          </c:extLst>
        </c:ser>
        <c:ser>
          <c:idx val="4"/>
          <c:order val="4"/>
          <c:tx>
            <c:strRef>
              <c:f>'CD8 graphs'!$B$24</c:f>
              <c:strCache>
                <c:ptCount val="1"/>
                <c:pt idx="0">
                  <c:v>15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strRef>
              <c:f>'CD8 graphs'!$C$19:$H$19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xVal>
          <c:yVal>
            <c:numRef>
              <c:f>'CD8 graphs'!$C$24:$H$24</c:f>
              <c:numCache>
                <c:formatCode>General</c:formatCode>
                <c:ptCount val="6"/>
                <c:pt idx="0">
                  <c:v>102156.912</c:v>
                </c:pt>
                <c:pt idx="1">
                  <c:v>213104.25</c:v>
                </c:pt>
                <c:pt idx="2">
                  <c:v>484745.31</c:v>
                </c:pt>
                <c:pt idx="3">
                  <c:v>1140942.6000000001</c:v>
                </c:pt>
                <c:pt idx="4">
                  <c:v>308580.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EB12-4131-821C-68A8BE0FD9A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11854320"/>
        <c:axId val="511867112"/>
      </c:scatterChart>
      <c:catAx>
        <c:axId val="52891168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528910704"/>
        <c:crosses val="autoZero"/>
        <c:auto val="1"/>
        <c:lblAlgn val="ctr"/>
        <c:lblOffset val="100"/>
        <c:noMultiLvlLbl val="0"/>
      </c:catAx>
      <c:valAx>
        <c:axId val="528910704"/>
        <c:scaling>
          <c:orientation val="minMax"/>
          <c:max val="25000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528911688"/>
        <c:crosses val="autoZero"/>
        <c:crossBetween val="between"/>
        <c:dispUnits>
          <c:builtInUnit val="hundredThousands"/>
          <c:dispUnitsLbl>
            <c:layout>
              <c:manualLayout>
                <c:xMode val="edge"/>
                <c:yMode val="edge"/>
                <c:x val="2.4346292462234492E-2"/>
                <c:y val="0.35100306748466259"/>
              </c:manualLayout>
            </c:layout>
            <c:tx>
              <c:rich>
                <a:bodyPr rot="-5400000" spcFirstLastPara="1" vertOverflow="ellipsis" vert="horz" wrap="square" anchor="ctr" anchorCtr="1"/>
                <a:lstStyle/>
                <a:p>
                  <a:pPr>
                    <a:defRPr sz="10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r>
                    <a:rPr lang="de-AT" sz="1000" b="0" i="0" baseline="0" dirty="0">
                      <a:effectLst/>
                    </a:rPr>
                    <a:t>10</a:t>
                  </a:r>
                  <a:r>
                    <a:rPr lang="de-AT" sz="1000" b="0" i="0" baseline="30000" dirty="0">
                      <a:effectLst/>
                    </a:rPr>
                    <a:t>5 </a:t>
                  </a:r>
                  <a:r>
                    <a:rPr lang="de-AT" sz="1000" b="0" i="0" baseline="0" dirty="0" err="1">
                      <a:effectLst/>
                    </a:rPr>
                    <a:t>cells</a:t>
                  </a:r>
                  <a:r>
                    <a:rPr lang="de-AT" sz="1000" b="0" i="0" baseline="0" dirty="0">
                      <a:effectLst/>
                    </a:rPr>
                    <a:t>/ml</a:t>
                  </a:r>
                  <a:endParaRPr lang="de-AT" sz="1000" dirty="0">
                    <a:effectLst/>
                  </a:endParaRPr>
                </a:p>
              </c:rich>
            </c:tx>
            <c:spPr>
              <a:noFill/>
              <a:ln>
                <a:noFill/>
              </a:ln>
              <a:effectLst/>
            </c:spPr>
            <c:txPr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de-DE"/>
              </a:p>
            </c:txPr>
          </c:dispUnitsLbl>
        </c:dispUnits>
      </c:valAx>
      <c:valAx>
        <c:axId val="511867112"/>
        <c:scaling>
          <c:orientation val="minMax"/>
          <c:max val="2500000"/>
        </c:scaling>
        <c:delete val="1"/>
        <c:axPos val="r"/>
        <c:numFmt formatCode="General" sourceLinked="1"/>
        <c:majorTickMark val="out"/>
        <c:minorTickMark val="none"/>
        <c:tickLblPos val="nextTo"/>
        <c:crossAx val="511854320"/>
        <c:crosses val="max"/>
        <c:crossBetween val="midCat"/>
      </c:valAx>
      <c:valAx>
        <c:axId val="511854320"/>
        <c:scaling>
          <c:orientation val="minMax"/>
        </c:scaling>
        <c:delete val="1"/>
        <c:axPos val="t"/>
        <c:majorTickMark val="out"/>
        <c:minorTickMark val="none"/>
        <c:tickLblPos val="nextTo"/>
        <c:crossAx val="511867112"/>
        <c:crosses val="max"/>
        <c:crossBetween val="midCat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de-AT"/>
              <a:t>vaccinated/challenged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title>
    <c:autoTitleDeleted val="0"/>
    <c:plotArea>
      <c:layout/>
      <c:lineChart>
        <c:grouping val="standard"/>
        <c:varyColors val="0"/>
        <c:ser>
          <c:idx val="5"/>
          <c:order val="5"/>
          <c:tx>
            <c:strRef>
              <c:f>'CD8 graphs'!$B$34</c:f>
              <c:strCache>
                <c:ptCount val="1"/>
                <c:pt idx="0">
                  <c:v>mean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strRef>
              <c:f>'CD8 graphs'!$C$28:$G$28</c:f>
              <c:strCache>
                <c:ptCount val="5"/>
                <c:pt idx="0">
                  <c:v>20 dpv</c:v>
                </c:pt>
                <c:pt idx="1">
                  <c:v>3 dpc</c:v>
                </c:pt>
                <c:pt idx="2">
                  <c:v>5 dpc</c:v>
                </c:pt>
                <c:pt idx="3">
                  <c:v>7 dpc</c:v>
                </c:pt>
                <c:pt idx="4">
                  <c:v>14 dpc</c:v>
                </c:pt>
              </c:strCache>
            </c:strRef>
          </c:cat>
          <c:val>
            <c:numRef>
              <c:f>'CD8 graphs'!$C$34:$G$34</c:f>
              <c:numCache>
                <c:formatCode>General</c:formatCode>
                <c:ptCount val="5"/>
                <c:pt idx="0">
                  <c:v>490594.02600000007</c:v>
                </c:pt>
                <c:pt idx="1">
                  <c:v>1319222.0266666666</c:v>
                </c:pt>
                <c:pt idx="2">
                  <c:v>239880.68919999999</c:v>
                </c:pt>
                <c:pt idx="3">
                  <c:v>302113.36200000002</c:v>
                </c:pt>
                <c:pt idx="4">
                  <c:v>134321.610000000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8A33-4D14-8611-6BA6FC0FC87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09753768"/>
        <c:axId val="409752456"/>
      </c:lineChart>
      <c:scatterChart>
        <c:scatterStyle val="lineMarker"/>
        <c:varyColors val="0"/>
        <c:ser>
          <c:idx val="0"/>
          <c:order val="0"/>
          <c:tx>
            <c:strRef>
              <c:f>'CD8 graphs'!$B$29</c:f>
              <c:strCache>
                <c:ptCount val="1"/>
                <c:pt idx="0">
                  <c:v>16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strRef>
              <c:f>'CD8 graphs'!$C$28:$G$28</c:f>
              <c:strCache>
                <c:ptCount val="5"/>
                <c:pt idx="0">
                  <c:v>20 dpv</c:v>
                </c:pt>
                <c:pt idx="1">
                  <c:v>3 dpc</c:v>
                </c:pt>
                <c:pt idx="2">
                  <c:v>5 dpc</c:v>
                </c:pt>
                <c:pt idx="3">
                  <c:v>7 dpc</c:v>
                </c:pt>
                <c:pt idx="4">
                  <c:v>14 dpc</c:v>
                </c:pt>
              </c:strCache>
            </c:strRef>
          </c:xVal>
          <c:yVal>
            <c:numRef>
              <c:f>'CD8 graphs'!$C$29:$G$29</c:f>
              <c:numCache>
                <c:formatCode>General</c:formatCode>
                <c:ptCount val="5"/>
                <c:pt idx="0">
                  <c:v>404253.85</c:v>
                </c:pt>
                <c:pt idx="1">
                  <c:v>1587733.3333333335</c:v>
                </c:pt>
                <c:pt idx="2">
                  <c:v>277967</c:v>
                </c:pt>
                <c:pt idx="3">
                  <c:v>242160.24</c:v>
                </c:pt>
                <c:pt idx="4">
                  <c:v>134546.1600000000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8A33-4D14-8611-6BA6FC0FC877}"/>
            </c:ext>
          </c:extLst>
        </c:ser>
        <c:ser>
          <c:idx val="1"/>
          <c:order val="1"/>
          <c:tx>
            <c:strRef>
              <c:f>'CD8 graphs'!$B$30</c:f>
              <c:strCache>
                <c:ptCount val="1"/>
                <c:pt idx="0">
                  <c:v>17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strRef>
              <c:f>'CD8 graphs'!$C$28:$G$28</c:f>
              <c:strCache>
                <c:ptCount val="5"/>
                <c:pt idx="0">
                  <c:v>20 dpv</c:v>
                </c:pt>
                <c:pt idx="1">
                  <c:v>3 dpc</c:v>
                </c:pt>
                <c:pt idx="2">
                  <c:v>5 dpc</c:v>
                </c:pt>
                <c:pt idx="3">
                  <c:v>7 dpc</c:v>
                </c:pt>
                <c:pt idx="4">
                  <c:v>14 dpc</c:v>
                </c:pt>
              </c:strCache>
            </c:strRef>
          </c:xVal>
          <c:yVal>
            <c:numRef>
              <c:f>'CD8 graphs'!$C$30:$G$30</c:f>
              <c:numCache>
                <c:formatCode>General</c:formatCode>
                <c:ptCount val="5"/>
                <c:pt idx="0">
                  <c:v>572372.71000000008</c:v>
                </c:pt>
                <c:pt idx="1">
                  <c:v>1343518.4</c:v>
                </c:pt>
                <c:pt idx="2">
                  <c:v>157965.12000000002</c:v>
                </c:pt>
                <c:pt idx="3">
                  <c:v>194109</c:v>
                </c:pt>
                <c:pt idx="4">
                  <c:v>134097.0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8A33-4D14-8611-6BA6FC0FC877}"/>
            </c:ext>
          </c:extLst>
        </c:ser>
        <c:ser>
          <c:idx val="2"/>
          <c:order val="2"/>
          <c:tx>
            <c:strRef>
              <c:f>'CD8 graphs'!$B$31</c:f>
              <c:strCache>
                <c:ptCount val="1"/>
                <c:pt idx="0">
                  <c:v>18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strRef>
              <c:f>'CD8 graphs'!$C$28:$G$28</c:f>
              <c:strCache>
                <c:ptCount val="5"/>
                <c:pt idx="0">
                  <c:v>20 dpv</c:v>
                </c:pt>
                <c:pt idx="1">
                  <c:v>3 dpc</c:v>
                </c:pt>
                <c:pt idx="2">
                  <c:v>5 dpc</c:v>
                </c:pt>
                <c:pt idx="3">
                  <c:v>7 dpc</c:v>
                </c:pt>
                <c:pt idx="4">
                  <c:v>14 dpc</c:v>
                </c:pt>
              </c:strCache>
            </c:strRef>
          </c:xVal>
          <c:yVal>
            <c:numRef>
              <c:f>'CD8 graphs'!$C$31:$G$31</c:f>
              <c:numCache>
                <c:formatCode>General</c:formatCode>
                <c:ptCount val="5"/>
                <c:pt idx="0">
                  <c:v>509123.72000000009</c:v>
                </c:pt>
                <c:pt idx="1">
                  <c:v>756756</c:v>
                </c:pt>
                <c:pt idx="2">
                  <c:v>107006.576</c:v>
                </c:pt>
                <c:pt idx="3">
                  <c:v>140781.3749999999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8A33-4D14-8611-6BA6FC0FC877}"/>
            </c:ext>
          </c:extLst>
        </c:ser>
        <c:ser>
          <c:idx val="3"/>
          <c:order val="3"/>
          <c:tx>
            <c:strRef>
              <c:f>'CD8 graphs'!$B$32</c:f>
              <c:strCache>
                <c:ptCount val="1"/>
                <c:pt idx="0">
                  <c:v>19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strRef>
              <c:f>'CD8 graphs'!$C$28:$G$28</c:f>
              <c:strCache>
                <c:ptCount val="5"/>
                <c:pt idx="0">
                  <c:v>20 dpv</c:v>
                </c:pt>
                <c:pt idx="1">
                  <c:v>3 dpc</c:v>
                </c:pt>
                <c:pt idx="2">
                  <c:v>5 dpc</c:v>
                </c:pt>
                <c:pt idx="3">
                  <c:v>7 dpc</c:v>
                </c:pt>
                <c:pt idx="4">
                  <c:v>14 dpc</c:v>
                </c:pt>
              </c:strCache>
            </c:strRef>
          </c:xVal>
          <c:yVal>
            <c:numRef>
              <c:f>'CD8 graphs'!$C$32:$G$32</c:f>
              <c:numCache>
                <c:formatCode>General</c:formatCode>
                <c:ptCount val="5"/>
                <c:pt idx="0">
                  <c:v>607466.25</c:v>
                </c:pt>
                <c:pt idx="1">
                  <c:v>1148162.3999999999</c:v>
                </c:pt>
                <c:pt idx="2">
                  <c:v>163735.16000000003</c:v>
                </c:pt>
                <c:pt idx="3">
                  <c:v>179061.79500000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8A33-4D14-8611-6BA6FC0FC877}"/>
            </c:ext>
          </c:extLst>
        </c:ser>
        <c:ser>
          <c:idx val="4"/>
          <c:order val="4"/>
          <c:tx>
            <c:strRef>
              <c:f>'CD8 graphs'!$B$33</c:f>
              <c:strCache>
                <c:ptCount val="1"/>
                <c:pt idx="0">
                  <c:v>20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strRef>
              <c:f>'CD8 graphs'!$C$28:$G$28</c:f>
              <c:strCache>
                <c:ptCount val="5"/>
                <c:pt idx="0">
                  <c:v>20 dpv</c:v>
                </c:pt>
                <c:pt idx="1">
                  <c:v>3 dpc</c:v>
                </c:pt>
                <c:pt idx="2">
                  <c:v>5 dpc</c:v>
                </c:pt>
                <c:pt idx="3">
                  <c:v>7 dpc</c:v>
                </c:pt>
                <c:pt idx="4">
                  <c:v>14 dpc</c:v>
                </c:pt>
              </c:strCache>
            </c:strRef>
          </c:xVal>
          <c:yVal>
            <c:numRef>
              <c:f>'CD8 graphs'!$C$33:$G$33</c:f>
              <c:numCache>
                <c:formatCode>General</c:formatCode>
                <c:ptCount val="5"/>
                <c:pt idx="0">
                  <c:v>359753.6</c:v>
                </c:pt>
                <c:pt idx="1">
                  <c:v>1759940</c:v>
                </c:pt>
                <c:pt idx="2">
                  <c:v>492729.59</c:v>
                </c:pt>
                <c:pt idx="3">
                  <c:v>754454.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8A33-4D14-8611-6BA6FC0FC87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26282344"/>
        <c:axId val="526275456"/>
      </c:scatterChart>
      <c:catAx>
        <c:axId val="4097537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409752456"/>
        <c:crosses val="autoZero"/>
        <c:auto val="1"/>
        <c:lblAlgn val="ctr"/>
        <c:lblOffset val="100"/>
        <c:noMultiLvlLbl val="0"/>
      </c:catAx>
      <c:valAx>
        <c:axId val="409752456"/>
        <c:scaling>
          <c:orientation val="minMax"/>
          <c:max val="25000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409753768"/>
        <c:crosses val="autoZero"/>
        <c:crossBetween val="between"/>
        <c:dispUnits>
          <c:builtInUnit val="hundredThousands"/>
          <c:dispUnitsLbl>
            <c:layout>
              <c:manualLayout>
                <c:xMode val="edge"/>
                <c:yMode val="edge"/>
                <c:x val="2.4346292462234492E-2"/>
                <c:y val="0.35100306748466259"/>
              </c:manualLayout>
            </c:layout>
            <c:tx>
              <c:rich>
                <a:bodyPr rot="-5400000" spcFirstLastPara="1" vertOverflow="ellipsis" vert="horz" wrap="square" anchor="ctr" anchorCtr="1"/>
                <a:lstStyle/>
                <a:p>
                  <a:pPr>
                    <a:defRPr sz="10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r>
                    <a:rPr lang="de-AT" sz="1000" b="0" i="0" baseline="0">
                      <a:effectLst/>
                    </a:rPr>
                    <a:t>10</a:t>
                  </a:r>
                  <a:r>
                    <a:rPr lang="de-AT" sz="1000" b="0" i="0" baseline="30000">
                      <a:effectLst/>
                    </a:rPr>
                    <a:t>5 </a:t>
                  </a:r>
                  <a:r>
                    <a:rPr lang="de-AT" sz="1000" b="0" i="0" baseline="0">
                      <a:effectLst/>
                    </a:rPr>
                    <a:t>cells/ml</a:t>
                  </a:r>
                  <a:endParaRPr lang="de-AT" sz="1000">
                    <a:effectLst/>
                  </a:endParaRPr>
                </a:p>
              </c:rich>
            </c:tx>
            <c:spPr>
              <a:noFill/>
              <a:ln>
                <a:noFill/>
              </a:ln>
              <a:effectLst/>
            </c:spPr>
            <c:txPr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de-DE"/>
              </a:p>
            </c:txPr>
          </c:dispUnitsLbl>
        </c:dispUnits>
      </c:valAx>
      <c:valAx>
        <c:axId val="526275456"/>
        <c:scaling>
          <c:orientation val="minMax"/>
          <c:max val="2500000"/>
        </c:scaling>
        <c:delete val="1"/>
        <c:axPos val="r"/>
        <c:numFmt formatCode="General" sourceLinked="1"/>
        <c:majorTickMark val="out"/>
        <c:minorTickMark val="none"/>
        <c:tickLblPos val="nextTo"/>
        <c:crossAx val="526282344"/>
        <c:crosses val="max"/>
        <c:crossBetween val="midCat"/>
      </c:valAx>
      <c:valAx>
        <c:axId val="526282344"/>
        <c:scaling>
          <c:orientation val="minMax"/>
        </c:scaling>
        <c:delete val="1"/>
        <c:axPos val="t"/>
        <c:majorTickMark val="out"/>
        <c:minorTickMark val="none"/>
        <c:tickLblPos val="nextTo"/>
        <c:crossAx val="526275456"/>
        <c:crosses val="max"/>
        <c:crossBetween val="midCat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535F68-5CFD-4566-A7FF-B5BD41AAF4CA}" type="datetimeFigureOut">
              <a:rPr lang="en-GB" smtClean="0"/>
              <a:t>30/07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8D037-0270-4989-B86F-8C754CBB28D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946294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535F68-5CFD-4566-A7FF-B5BD41AAF4CA}" type="datetimeFigureOut">
              <a:rPr lang="en-GB" smtClean="0"/>
              <a:t>30/07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8D037-0270-4989-B86F-8C754CBB28D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752533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535F68-5CFD-4566-A7FF-B5BD41AAF4CA}" type="datetimeFigureOut">
              <a:rPr lang="en-GB" smtClean="0"/>
              <a:t>30/07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8D037-0270-4989-B86F-8C754CBB28D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874029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535F68-5CFD-4566-A7FF-B5BD41AAF4CA}" type="datetimeFigureOut">
              <a:rPr lang="en-GB" smtClean="0"/>
              <a:t>30/07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8D037-0270-4989-B86F-8C754CBB28D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216784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535F68-5CFD-4566-A7FF-B5BD41AAF4CA}" type="datetimeFigureOut">
              <a:rPr lang="en-GB" smtClean="0"/>
              <a:t>30/07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8D037-0270-4989-B86F-8C754CBB28D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51903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535F68-5CFD-4566-A7FF-B5BD41AAF4CA}" type="datetimeFigureOut">
              <a:rPr lang="en-GB" smtClean="0"/>
              <a:t>30/07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8D037-0270-4989-B86F-8C754CBB28D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337033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535F68-5CFD-4566-A7FF-B5BD41AAF4CA}" type="datetimeFigureOut">
              <a:rPr lang="en-GB" smtClean="0"/>
              <a:t>30/07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8D037-0270-4989-B86F-8C754CBB28D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531989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535F68-5CFD-4566-A7FF-B5BD41AAF4CA}" type="datetimeFigureOut">
              <a:rPr lang="en-GB" smtClean="0"/>
              <a:t>30/07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8D037-0270-4989-B86F-8C754CBB28D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570892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535F68-5CFD-4566-A7FF-B5BD41AAF4CA}" type="datetimeFigureOut">
              <a:rPr lang="en-GB" smtClean="0"/>
              <a:t>30/07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8D037-0270-4989-B86F-8C754CBB28D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696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535F68-5CFD-4566-A7FF-B5BD41AAF4CA}" type="datetimeFigureOut">
              <a:rPr lang="en-GB" smtClean="0"/>
              <a:t>30/07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8D037-0270-4989-B86F-8C754CBB28D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105483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535F68-5CFD-4566-A7FF-B5BD41AAF4CA}" type="datetimeFigureOut">
              <a:rPr lang="en-GB" smtClean="0"/>
              <a:t>30/07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8D037-0270-4989-B86F-8C754CBB28D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549326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535F68-5CFD-4566-A7FF-B5BD41AAF4CA}" type="datetimeFigureOut">
              <a:rPr lang="en-GB" smtClean="0"/>
              <a:t>30/07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A8D037-0270-4989-B86F-8C754CBB28D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167036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/>
          <p:cNvGrpSpPr/>
          <p:nvPr/>
        </p:nvGrpSpPr>
        <p:grpSpPr>
          <a:xfrm>
            <a:off x="336588" y="181408"/>
            <a:ext cx="11118889" cy="6408799"/>
            <a:chOff x="336588" y="181408"/>
            <a:chExt cx="11118889" cy="6408799"/>
          </a:xfrm>
        </p:grpSpPr>
        <p:grpSp>
          <p:nvGrpSpPr>
            <p:cNvPr id="3" name="Group 2"/>
            <p:cNvGrpSpPr/>
            <p:nvPr/>
          </p:nvGrpSpPr>
          <p:grpSpPr>
            <a:xfrm>
              <a:off x="336588" y="181408"/>
              <a:ext cx="11118889" cy="6408799"/>
              <a:chOff x="336588" y="181408"/>
              <a:chExt cx="11118889" cy="6408799"/>
            </a:xfrm>
          </p:grpSpPr>
          <p:grpSp>
            <p:nvGrpSpPr>
              <p:cNvPr id="2" name="Group 1"/>
              <p:cNvGrpSpPr/>
              <p:nvPr/>
            </p:nvGrpSpPr>
            <p:grpSpPr>
              <a:xfrm>
                <a:off x="336588" y="206122"/>
                <a:ext cx="11118889" cy="6384085"/>
                <a:chOff x="336588" y="206122"/>
                <a:chExt cx="11118889" cy="6384085"/>
              </a:xfrm>
            </p:grpSpPr>
            <p:graphicFrame>
              <p:nvGraphicFramePr>
                <p:cNvPr id="23" name="Chart 22"/>
                <p:cNvGraphicFramePr/>
                <p:nvPr>
                  <p:extLst>
                    <p:ext uri="{D42A27DB-BD31-4B8C-83A1-F6EECF244321}">
                      <p14:modId xmlns:p14="http://schemas.microsoft.com/office/powerpoint/2010/main" val="2119228140"/>
                    </p:ext>
                  </p:extLst>
                </p:nvPr>
              </p:nvGraphicFramePr>
              <p:xfrm>
                <a:off x="336588" y="206122"/>
                <a:ext cx="5216400" cy="29340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2"/>
                </a:graphicData>
              </a:graphic>
            </p:graphicFrame>
            <p:graphicFrame>
              <p:nvGraphicFramePr>
                <p:cNvPr id="24" name="Chart 23"/>
                <p:cNvGraphicFramePr/>
                <p:nvPr>
                  <p:extLst>
                    <p:ext uri="{D42A27DB-BD31-4B8C-83A1-F6EECF244321}">
                      <p14:modId xmlns:p14="http://schemas.microsoft.com/office/powerpoint/2010/main" val="258843761"/>
                    </p:ext>
                  </p:extLst>
                </p:nvPr>
              </p:nvGraphicFramePr>
              <p:xfrm>
                <a:off x="6239077" y="206122"/>
                <a:ext cx="5216400" cy="29340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3"/>
                </a:graphicData>
              </a:graphic>
            </p:graphicFrame>
            <p:graphicFrame>
              <p:nvGraphicFramePr>
                <p:cNvPr id="25" name="Chart 24"/>
                <p:cNvGraphicFramePr/>
                <p:nvPr>
                  <p:extLst>
                    <p:ext uri="{D42A27DB-BD31-4B8C-83A1-F6EECF244321}">
                      <p14:modId xmlns:p14="http://schemas.microsoft.com/office/powerpoint/2010/main" val="282208272"/>
                    </p:ext>
                  </p:extLst>
                </p:nvPr>
              </p:nvGraphicFramePr>
              <p:xfrm>
                <a:off x="336588" y="3656207"/>
                <a:ext cx="5216400" cy="29340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4"/>
                </a:graphicData>
              </a:graphic>
            </p:graphicFrame>
            <p:graphicFrame>
              <p:nvGraphicFramePr>
                <p:cNvPr id="26" name="Chart 25"/>
                <p:cNvGraphicFramePr/>
                <p:nvPr>
                  <p:extLst>
                    <p:ext uri="{D42A27DB-BD31-4B8C-83A1-F6EECF244321}">
                      <p14:modId xmlns:p14="http://schemas.microsoft.com/office/powerpoint/2010/main" val="1676517749"/>
                    </p:ext>
                  </p:extLst>
                </p:nvPr>
              </p:nvGraphicFramePr>
              <p:xfrm>
                <a:off x="6239077" y="3656207"/>
                <a:ext cx="5216400" cy="29340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5"/>
                </a:graphicData>
              </a:graphic>
            </p:graphicFrame>
          </p:grpSp>
          <p:sp>
            <p:nvSpPr>
              <p:cNvPr id="8" name="TextBox 7"/>
              <p:cNvSpPr txBox="1"/>
              <p:nvPr/>
            </p:nvSpPr>
            <p:spPr>
              <a:xfrm>
                <a:off x="337393" y="181408"/>
                <a:ext cx="31143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dirty="0"/>
                  <a:t>A</a:t>
                </a:r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>
                <a:off x="6185622" y="181408"/>
                <a:ext cx="31143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dirty="0" smtClean="0"/>
                  <a:t>B</a:t>
                </a:r>
                <a:endParaRPr lang="en-GB" dirty="0"/>
              </a:p>
            </p:txBody>
          </p:sp>
          <p:sp>
            <p:nvSpPr>
              <p:cNvPr id="10" name="TextBox 9"/>
              <p:cNvSpPr txBox="1"/>
              <p:nvPr/>
            </p:nvSpPr>
            <p:spPr>
              <a:xfrm>
                <a:off x="337393" y="3560731"/>
                <a:ext cx="31143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dirty="0" smtClean="0"/>
                  <a:t>C</a:t>
                </a:r>
                <a:endParaRPr lang="en-GB" dirty="0"/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>
                <a:off x="6185622" y="3560731"/>
                <a:ext cx="31143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dirty="0" smtClean="0"/>
                  <a:t>D</a:t>
                </a:r>
                <a:endParaRPr lang="en-GB" dirty="0"/>
              </a:p>
            </p:txBody>
          </p:sp>
        </p:grpSp>
        <p:sp>
          <p:nvSpPr>
            <p:cNvPr id="35" name="TextBox 34"/>
            <p:cNvSpPr txBox="1"/>
            <p:nvPr/>
          </p:nvSpPr>
          <p:spPr>
            <a:xfrm>
              <a:off x="7159158" y="5283106"/>
              <a:ext cx="180756" cy="28684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400" b="1" dirty="0">
                  <a:solidFill>
                    <a:srgbClr val="000000"/>
                  </a:solidFill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de-AT" sz="12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4185536" y="5123207"/>
              <a:ext cx="180756" cy="28684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400" b="1" dirty="0">
                  <a:solidFill>
                    <a:srgbClr val="000000"/>
                  </a:solidFill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de-AT" sz="12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8065320" y="4415077"/>
              <a:ext cx="180756" cy="28684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400" b="1" dirty="0">
                  <a:solidFill>
                    <a:srgbClr val="000000"/>
                  </a:solidFill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de-AT" sz="12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3443893" y="3905349"/>
              <a:ext cx="180756" cy="28684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400" b="1" dirty="0">
                  <a:solidFill>
                    <a:srgbClr val="000000"/>
                  </a:solidFill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de-AT" sz="12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9881783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4</Words>
  <Application>Microsoft Office PowerPoint</Application>
  <PresentationFormat>Widescreen</PresentationFormat>
  <Paragraphs>1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Calibri</vt:lpstr>
      <vt:lpstr>Calibri Light</vt:lpstr>
      <vt:lpstr>Times New Roman</vt:lpstr>
      <vt:lpstr>Arial</vt:lpstr>
      <vt:lpstr>Office Theme</vt:lpstr>
      <vt:lpstr>PowerPoint Presentation</vt:lpstr>
    </vt:vector>
  </TitlesOfParts>
  <Company>Vetmeduni Vienn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e Luca Carlotta</dc:creator>
  <cp:lastModifiedBy>De Luca Carlotta</cp:lastModifiedBy>
  <cp:revision>11</cp:revision>
  <dcterms:created xsi:type="dcterms:W3CDTF">2020-07-30T11:05:44Z</dcterms:created>
  <dcterms:modified xsi:type="dcterms:W3CDTF">2020-07-30T12:29:36Z</dcterms:modified>
</cp:coreProperties>
</file>